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19588" cy="4319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8D8A5-706F-4A56-878C-EE85BEAFB0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388944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6000" y="2498040"/>
            <a:ext cx="388944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C2426-06B2-4D1D-9C82-C0D4C9DE7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09320" y="100800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6000" y="249804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09320" y="249804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266BD-43A9-40B6-843E-020323586B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125208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31080" y="1008000"/>
            <a:ext cx="125208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46160" y="1008000"/>
            <a:ext cx="125208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6000" y="2498040"/>
            <a:ext cx="125208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31080" y="2498040"/>
            <a:ext cx="125208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46160" y="2498040"/>
            <a:ext cx="125208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C52C0-41F5-4139-A7A1-2648C1BB73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6000" y="1008000"/>
            <a:ext cx="3889440" cy="285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25"/>
              </a:spcBef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932B5-0539-4A51-A519-22E36A7C88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3889440" cy="28526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17F05-FE26-49BC-A897-1F887D97DB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1897920" cy="28526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09320" y="1008000"/>
            <a:ext cx="1897920" cy="28526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1546C-D684-4C19-8E56-4883129443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DB1CF-7F3F-4EC8-9752-5E0780A4C3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6000" y="173160"/>
            <a:ext cx="3889440" cy="3342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25"/>
              </a:spcBef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F11AB-5B8B-440F-9217-C83F839590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09320" y="1008000"/>
            <a:ext cx="1897920" cy="28526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6000" y="249804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ED669-492D-453F-8E6F-13B640B360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1897920" cy="28526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09320" y="100800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09320" y="249804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7FECD-7CE4-4DD4-B59D-E5F2DBA45A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6000" y="100800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09320" y="1008000"/>
            <a:ext cx="189792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6000" y="2498040"/>
            <a:ext cx="3889440" cy="13604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359B6-4C79-4756-8171-F62B9D83A6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6000" y="173160"/>
            <a:ext cx="3889440" cy="72072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6000" y="1008000"/>
            <a:ext cx="3889440" cy="28526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t">
            <a:normAutofit/>
          </a:bodyPr>
          <a:p>
            <a:pPr marL="184320" indent="-184320">
              <a:spcBef>
                <a:spcPts val="425"/>
              </a:spcBef>
              <a:buClr>
                <a:srgbClr val="000000"/>
              </a:buClr>
              <a:buFont typeface="Arial"/>
              <a:buChar char="•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1" marL="399960" indent="-153720">
              <a:spcBef>
                <a:spcPts val="425"/>
              </a:spcBef>
              <a:buClr>
                <a:srgbClr val="000000"/>
              </a:buClr>
              <a:buFont typeface="Arial"/>
              <a:buChar char="–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2" marL="615960" indent="-122400">
              <a:spcBef>
                <a:spcPts val="425"/>
              </a:spcBef>
              <a:buClr>
                <a:srgbClr val="000000"/>
              </a:buClr>
              <a:buFont typeface="Arial"/>
              <a:buChar char="•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3" marL="863640" indent="-122400">
              <a:spcBef>
                <a:spcPts val="425"/>
              </a:spcBef>
              <a:buClr>
                <a:srgbClr val="000000"/>
              </a:buClr>
              <a:buFont typeface="Arial"/>
              <a:buChar char="–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4" marL="1109520" indent="-12204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5" marL="1109520" indent="-12204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6" marL="1109520" indent="-12204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6000" y="4005000"/>
            <a:ext cx="1008000" cy="2300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  <a:defRPr b="0" lang="it-IT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it-IT" sz="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76000" y="4005000"/>
            <a:ext cx="1368360" cy="2300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p>
            <a:pPr indent="0"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96720" y="4005000"/>
            <a:ext cx="1008360" cy="230040"/>
          </a:xfrm>
          <a:prstGeom prst="rect">
            <a:avLst/>
          </a:prstGeom>
          <a:noFill/>
          <a:ln w="0">
            <a:noFill/>
          </a:ln>
        </p:spPr>
        <p:txBody>
          <a:bodyPr lIns="49320" rIns="49320" tIns="24840" bIns="248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  <a:defRPr b="0" lang="it-IT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fld id="{845C19AD-6C67-43E7-BB89-E1C906DBF2C7}" type="slidenum">
              <a:rPr b="0" lang="it-IT" sz="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8"/>
          <p:cNvSpPr/>
          <p:nvPr/>
        </p:nvSpPr>
        <p:spPr>
          <a:xfrm>
            <a:off x="2679840" y="0"/>
            <a:ext cx="4316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9"/>
          <p:cNvSpPr/>
          <p:nvPr/>
        </p:nvSpPr>
        <p:spPr>
          <a:xfrm>
            <a:off x="2608200" y="177840"/>
            <a:ext cx="43200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1"/>
          <p:cNvSpPr/>
          <p:nvPr/>
        </p:nvSpPr>
        <p:spPr>
          <a:xfrm>
            <a:off x="2049480" y="26028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M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asellaDiTesto 11"/>
          <p:cNvSpPr/>
          <p:nvPr/>
        </p:nvSpPr>
        <p:spPr>
          <a:xfrm>
            <a:off x="73080" y="3017880"/>
            <a:ext cx="4248000" cy="100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gure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2.  Growth curve of the complemented </a:t>
            </a:r>
            <a:r>
              <a:rPr b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nu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: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n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rain in modM9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owth curves of wild type (squares),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nu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: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n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circles) and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nu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: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n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ontaining p18ZnuAO157 (triangles) or p18ZnuAE.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li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iamonds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93560"/>
                <a:tab algn="l" pos="987480"/>
                <a:tab algn="l" pos="1481040"/>
                <a:tab algn="l" pos="1974960"/>
                <a:tab algn="l" pos="2468520"/>
                <a:tab algn="l" pos="2962440"/>
                <a:tab algn="l" pos="3456000"/>
                <a:tab algn="l" pos="3949560"/>
                <a:tab algn="l" pos="4443480"/>
                <a:tab algn="l" pos="4937040"/>
                <a:tab algn="l" pos="5430960"/>
                <a:tab algn="l" pos="5924520"/>
                <a:tab algn="l" pos="6418440"/>
                <a:tab algn="l" pos="6912000"/>
                <a:tab algn="l" pos="7405560"/>
                <a:tab algn="l" pos="7899480"/>
                <a:tab algn="l" pos="8393040"/>
                <a:tab algn="l" pos="8886960"/>
                <a:tab algn="l" pos="9380520"/>
                <a:tab algn="l" pos="987408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9" descr=""/>
          <p:cNvPicPr/>
          <p:nvPr/>
        </p:nvPicPr>
        <p:blipFill>
          <a:blip r:embed="rId1"/>
          <a:stretch/>
        </p:blipFill>
        <p:spPr>
          <a:xfrm>
            <a:off x="303120" y="17640"/>
            <a:ext cx="3800520" cy="2866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16:35:26Z</dcterms:created>
  <dc:creator>Claudia Signoretti</dc:creator>
  <dc:description/>
  <dc:language>en-US</dc:language>
  <cp:lastModifiedBy>Utente</cp:lastModifiedBy>
  <dcterms:modified xsi:type="dcterms:W3CDTF">2011-02-15T11:10:01Z</dcterms:modified>
  <cp:revision>6</cp:revision>
  <dc:subject/>
  <dc:title>Diapositiva 1</dc:title>
</cp:coreProperties>
</file>